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et-E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Indrek Teino" initials="IT" lastIdx="2" clrIdx="0">
    <p:extLst>
      <p:ext uri="{19B8F6BF-5375-455C-9EA6-DF929625EA0E}">
        <p15:presenceInfo xmlns:p15="http://schemas.microsoft.com/office/powerpoint/2012/main" userId="S-1-5-21-2983161654-3330284812-1284754214-43340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F5FC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2" d="100"/>
          <a:sy n="62" d="100"/>
        </p:scale>
        <p:origin x="1400" y="5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user2\Desktop\CaCo2%20Dif\Tryptan_Blue_Exclusion%20(4)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7"/>
    </mc:Choice>
    <mc:Fallback>
      <c:style val="7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8326170945435241"/>
          <c:y val="7.2898634685989352E-2"/>
          <c:w val="0.7921087051618545"/>
          <c:h val="0.79872913949598356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rgbClr val="FFFF00"/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0-199D-4669-9218-C7932C9EC43A}"/>
              </c:ext>
            </c:extLst>
          </c:dPt>
          <c:dPt>
            <c:idx val="1"/>
            <c:invertIfNegative val="0"/>
            <c:bubble3D val="0"/>
            <c:spPr>
              <a:solidFill>
                <a:srgbClr val="FFC000"/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199D-4669-9218-C7932C9EC43A}"/>
              </c:ext>
            </c:extLst>
          </c:dPt>
          <c:dPt>
            <c:idx val="2"/>
            <c:invertIfNegative val="0"/>
            <c:bubble3D val="0"/>
            <c:spPr>
              <a:solidFill>
                <a:srgbClr val="92D050"/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2-199D-4669-9218-C7932C9EC43A}"/>
              </c:ext>
            </c:extLst>
          </c:dPt>
          <c:dPt>
            <c:idx val="3"/>
            <c:invertIfNegative val="0"/>
            <c:bubble3D val="0"/>
            <c:spPr>
              <a:solidFill>
                <a:srgbClr val="00B0F0"/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199D-4669-9218-C7932C9EC43A}"/>
              </c:ext>
            </c:extLst>
          </c:dPt>
          <c:dPt>
            <c:idx val="4"/>
            <c:invertIfNegative val="0"/>
            <c:bubble3D val="0"/>
            <c:spPr>
              <a:solidFill>
                <a:srgbClr val="9F5FCF"/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4-199D-4669-9218-C7932C9EC43A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B$15:$F$15</c:f>
                <c:numCache>
                  <c:formatCode>General</c:formatCode>
                  <c:ptCount val="5"/>
                  <c:pt idx="0">
                    <c:v>4.4698212072681744E-2</c:v>
                  </c:pt>
                  <c:pt idx="1">
                    <c:v>2.9952900725709691E-2</c:v>
                  </c:pt>
                  <c:pt idx="2">
                    <c:v>1.5557708863335996E-2</c:v>
                  </c:pt>
                  <c:pt idx="3">
                    <c:v>5.3654981636257169E-2</c:v>
                  </c:pt>
                  <c:pt idx="4">
                    <c:v>7.0247187021131932E-2</c:v>
                  </c:pt>
                </c:numCache>
              </c:numRef>
            </c:plus>
            <c:minus>
              <c:numRef>
                <c:f>Sheet1!$B$15:$F$15</c:f>
                <c:numCache>
                  <c:formatCode>General</c:formatCode>
                  <c:ptCount val="5"/>
                  <c:pt idx="0">
                    <c:v>4.4698212072681744E-2</c:v>
                  </c:pt>
                  <c:pt idx="1">
                    <c:v>2.9952900725709691E-2</c:v>
                  </c:pt>
                  <c:pt idx="2">
                    <c:v>1.5557708863335996E-2</c:v>
                  </c:pt>
                  <c:pt idx="3">
                    <c:v>5.3654981636257169E-2</c:v>
                  </c:pt>
                  <c:pt idx="4">
                    <c:v>7.0247187021131932E-2</c:v>
                  </c:pt>
                </c:numCache>
              </c:numRef>
            </c:minus>
          </c:errBars>
          <c:cat>
            <c:strRef>
              <c:f>Sheet1!$B$5:$F$5</c:f>
              <c:strCache>
                <c:ptCount val="5"/>
                <c:pt idx="0">
                  <c:v>Control</c:v>
                </c:pt>
                <c:pt idx="1">
                  <c:v>1mM NaBT</c:v>
                </c:pt>
                <c:pt idx="2">
                  <c:v>2mM NaBT</c:v>
                </c:pt>
                <c:pt idx="3">
                  <c:v>5mM NaBT</c:v>
                </c:pt>
                <c:pt idx="4">
                  <c:v>10mM NaBT</c:v>
                </c:pt>
              </c:strCache>
            </c:strRef>
          </c:cat>
          <c:val>
            <c:numRef>
              <c:f>Sheet1!$B$14:$F$14</c:f>
              <c:numCache>
                <c:formatCode>0%</c:formatCode>
                <c:ptCount val="5"/>
                <c:pt idx="0">
                  <c:v>0.96808347697326569</c:v>
                </c:pt>
                <c:pt idx="1">
                  <c:v>0.66054295964657794</c:v>
                </c:pt>
                <c:pt idx="2">
                  <c:v>0.4615198591998354</c:v>
                </c:pt>
                <c:pt idx="3">
                  <c:v>0.4059016881869788</c:v>
                </c:pt>
                <c:pt idx="4">
                  <c:v>0.277377950041570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2FF-4CCE-9C1E-0CD066F72FF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4520704"/>
        <c:axId val="124534784"/>
      </c:barChart>
      <c:scatterChart>
        <c:scatterStyle val="lineMarker"/>
        <c:varyColors val="0"/>
        <c:ser>
          <c:idx val="1"/>
          <c:order val="1"/>
          <c:tx>
            <c:v>bar</c:v>
          </c:tx>
          <c:spPr>
            <a:ln w="12700">
              <a:solidFill>
                <a:sysClr val="windowText" lastClr="000000"/>
              </a:solidFill>
            </a:ln>
          </c:spPr>
          <c:marker>
            <c:symbol val="none"/>
          </c:marker>
          <c:xVal>
            <c:numRef>
              <c:f>Sheet1!$P$7:$P$9</c:f>
              <c:numCache>
                <c:formatCode>General</c:formatCode>
                <c:ptCount val="3"/>
                <c:pt idx="0">
                  <c:v>1</c:v>
                </c:pt>
                <c:pt idx="1">
                  <c:v>2</c:v>
                </c:pt>
                <c:pt idx="2">
                  <c:v>2</c:v>
                </c:pt>
              </c:numCache>
            </c:numRef>
          </c:xVal>
          <c:yVal>
            <c:numRef>
              <c:f>Sheet1!$Q$7:$Q$9</c:f>
              <c:numCache>
                <c:formatCode>General</c:formatCode>
                <c:ptCount val="3"/>
                <c:pt idx="0">
                  <c:v>1.05</c:v>
                </c:pt>
                <c:pt idx="1">
                  <c:v>1.05</c:v>
                </c:pt>
                <c:pt idx="2">
                  <c:v>0.7500000000000033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C2FF-4CCE-9C1E-0CD066F72FFB}"/>
            </c:ext>
          </c:extLst>
        </c:ser>
        <c:ser>
          <c:idx val="2"/>
          <c:order val="2"/>
          <c:spPr>
            <a:ln w="12700">
              <a:solidFill>
                <a:sysClr val="windowText" lastClr="000000"/>
              </a:solidFill>
            </a:ln>
          </c:spPr>
          <c:marker>
            <c:symbol val="none"/>
          </c:marker>
          <c:xVal>
            <c:numRef>
              <c:f>Sheet1!$P$10:$P$13</c:f>
              <c:numCache>
                <c:formatCode>General</c:formatCode>
                <c:ptCount val="4"/>
                <c:pt idx="0">
                  <c:v>1</c:v>
                </c:pt>
                <c:pt idx="1">
                  <c:v>1</c:v>
                </c:pt>
                <c:pt idx="2">
                  <c:v>3</c:v>
                </c:pt>
                <c:pt idx="3">
                  <c:v>3</c:v>
                </c:pt>
              </c:numCache>
            </c:numRef>
          </c:xVal>
          <c:yVal>
            <c:numRef>
              <c:f>Sheet1!$Q$10:$Q$13</c:f>
              <c:numCache>
                <c:formatCode>General</c:formatCode>
                <c:ptCount val="4"/>
                <c:pt idx="0">
                  <c:v>1.08</c:v>
                </c:pt>
                <c:pt idx="1">
                  <c:v>1.1100000000000001</c:v>
                </c:pt>
                <c:pt idx="2">
                  <c:v>1.1100000000000001</c:v>
                </c:pt>
                <c:pt idx="3">
                  <c:v>0.58000000000000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C2FF-4CCE-9C1E-0CD066F72FFB}"/>
            </c:ext>
          </c:extLst>
        </c:ser>
        <c:ser>
          <c:idx val="3"/>
          <c:order val="3"/>
          <c:spPr>
            <a:ln w="12700">
              <a:solidFill>
                <a:sysClr val="windowText" lastClr="000000"/>
              </a:solidFill>
            </a:ln>
          </c:spPr>
          <c:marker>
            <c:symbol val="none"/>
          </c:marker>
          <c:xVal>
            <c:numRef>
              <c:f>Sheet1!$R$6:$R$9</c:f>
              <c:numCache>
                <c:formatCode>General</c:formatCode>
                <c:ptCount val="4"/>
                <c:pt idx="0">
                  <c:v>1</c:v>
                </c:pt>
                <c:pt idx="1">
                  <c:v>1</c:v>
                </c:pt>
                <c:pt idx="2">
                  <c:v>4</c:v>
                </c:pt>
                <c:pt idx="3">
                  <c:v>4</c:v>
                </c:pt>
              </c:numCache>
            </c:numRef>
          </c:xVal>
          <c:yVal>
            <c:numRef>
              <c:f>Sheet1!$S$6:$S$9</c:f>
              <c:numCache>
                <c:formatCode>General</c:formatCode>
                <c:ptCount val="4"/>
                <c:pt idx="0">
                  <c:v>1.1499999999999928</c:v>
                </c:pt>
                <c:pt idx="1">
                  <c:v>1.1900000000000064</c:v>
                </c:pt>
                <c:pt idx="2">
                  <c:v>1.1900000000000064</c:v>
                </c:pt>
                <c:pt idx="3">
                  <c:v>0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C2FF-4CCE-9C1E-0CD066F72FFB}"/>
            </c:ext>
          </c:extLst>
        </c:ser>
        <c:ser>
          <c:idx val="4"/>
          <c:order val="4"/>
          <c:spPr>
            <a:ln w="12700">
              <a:solidFill>
                <a:sysClr val="windowText" lastClr="000000"/>
              </a:solidFill>
            </a:ln>
          </c:spPr>
          <c:marker>
            <c:symbol val="none"/>
          </c:marker>
          <c:xVal>
            <c:numRef>
              <c:f>Sheet1!$R$10:$R$13</c:f>
              <c:numCache>
                <c:formatCode>General</c:formatCode>
                <c:ptCount val="4"/>
                <c:pt idx="0">
                  <c:v>1</c:v>
                </c:pt>
                <c:pt idx="1">
                  <c:v>1</c:v>
                </c:pt>
                <c:pt idx="2">
                  <c:v>5</c:v>
                </c:pt>
                <c:pt idx="3">
                  <c:v>5</c:v>
                </c:pt>
              </c:numCache>
            </c:numRef>
          </c:xVal>
          <c:yVal>
            <c:numRef>
              <c:f>Sheet1!$S$10:$S$13</c:f>
              <c:numCache>
                <c:formatCode>General</c:formatCode>
                <c:ptCount val="4"/>
                <c:pt idx="0">
                  <c:v>1.22</c:v>
                </c:pt>
                <c:pt idx="1">
                  <c:v>1.25</c:v>
                </c:pt>
                <c:pt idx="2">
                  <c:v>1.25</c:v>
                </c:pt>
                <c:pt idx="3">
                  <c:v>0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C2FF-4CCE-9C1E-0CD066F72FF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520704"/>
        <c:axId val="124534784"/>
      </c:scatterChart>
      <c:catAx>
        <c:axId val="12452070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200" b="1"/>
            </a:pPr>
            <a:endParaRPr lang="en-US"/>
          </a:p>
        </c:txPr>
        <c:crossAx val="124534784"/>
        <c:crosses val="autoZero"/>
        <c:auto val="1"/>
        <c:lblAlgn val="ctr"/>
        <c:lblOffset val="100"/>
        <c:noMultiLvlLbl val="0"/>
      </c:catAx>
      <c:valAx>
        <c:axId val="124534784"/>
        <c:scaling>
          <c:orientation val="minMax"/>
          <c:max val="1.3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baseline="0" noProof="0" dirty="0"/>
                  <a:t>Number of viable cells</a:t>
                </a:r>
                <a:r>
                  <a:rPr lang="et-EE" baseline="0" noProof="0" dirty="0"/>
                  <a:t>, </a:t>
                </a:r>
                <a:r>
                  <a:rPr lang="en-US" baseline="0" noProof="0" dirty="0"/>
                  <a:t>% </a:t>
                </a:r>
                <a:endParaRPr lang="en-US" noProof="0" dirty="0"/>
              </a:p>
            </c:rich>
          </c:tx>
          <c:overlay val="0"/>
        </c:title>
        <c:numFmt formatCode="0%" sourceLinked="1"/>
        <c:majorTickMark val="out"/>
        <c:minorTickMark val="none"/>
        <c:tickLblPos val="nextTo"/>
        <c:spPr>
          <a:ln w="38100"/>
        </c:spPr>
        <c:txPr>
          <a:bodyPr/>
          <a:lstStyle/>
          <a:p>
            <a:pPr>
              <a:defRPr sz="1200" b="1"/>
            </a:pPr>
            <a:endParaRPr lang="en-US"/>
          </a:p>
        </c:txPr>
        <c:crossAx val="124520704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53333</cdr:x>
      <cdr:y>0.02475</cdr:y>
    </cdr:from>
    <cdr:to>
      <cdr:x>0.61667</cdr:x>
      <cdr:y>0.10144</cdr:y>
    </cdr:to>
    <cdr:sp macro="" textlink="">
      <cdr:nvSpPr>
        <cdr:cNvPr id="3" name="TextBox 1"/>
        <cdr:cNvSpPr txBox="1"/>
      </cdr:nvSpPr>
      <cdr:spPr>
        <a:xfrm xmlns:a="http://schemas.openxmlformats.org/drawingml/2006/main">
          <a:off x="1958605" y="64302"/>
          <a:ext cx="306059" cy="19924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r>
            <a:rPr lang="en-US" sz="1400" dirty="0"/>
            <a:t>***</a:t>
          </a:r>
        </a:p>
      </cdr:txBody>
    </cdr:sp>
  </cdr:relSizeAnchor>
  <cdr:relSizeAnchor xmlns:cdr="http://schemas.openxmlformats.org/drawingml/2006/chartDrawing">
    <cdr:from>
      <cdr:x>0.46667</cdr:x>
      <cdr:y>0.07426</cdr:y>
    </cdr:from>
    <cdr:to>
      <cdr:x>0.55</cdr:x>
      <cdr:y>0.15095</cdr:y>
    </cdr:to>
    <cdr:sp macro="" textlink="">
      <cdr:nvSpPr>
        <cdr:cNvPr id="4" name="TextBox 1"/>
        <cdr:cNvSpPr txBox="1"/>
      </cdr:nvSpPr>
      <cdr:spPr>
        <a:xfrm xmlns:a="http://schemas.openxmlformats.org/drawingml/2006/main">
          <a:off x="2000264" y="214314"/>
          <a:ext cx="357190" cy="22132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pPr>
            <a:lnSpc>
              <a:spcPts val="1900"/>
            </a:lnSpc>
          </a:pPr>
          <a:r>
            <a:rPr lang="en-US" sz="1400" dirty="0"/>
            <a:t>***</a:t>
          </a:r>
        </a:p>
      </cdr:txBody>
    </cdr:sp>
  </cdr:relSizeAnchor>
  <cdr:relSizeAnchor xmlns:cdr="http://schemas.openxmlformats.org/drawingml/2006/chartDrawing">
    <cdr:from>
      <cdr:x>0.36667</cdr:x>
      <cdr:y>0.12376</cdr:y>
    </cdr:from>
    <cdr:to>
      <cdr:x>0.45</cdr:x>
      <cdr:y>0.20045</cdr:y>
    </cdr:to>
    <cdr:sp macro="" textlink="">
      <cdr:nvSpPr>
        <cdr:cNvPr id="5" name="TextBox 1"/>
        <cdr:cNvSpPr txBox="1"/>
      </cdr:nvSpPr>
      <cdr:spPr>
        <a:xfrm xmlns:a="http://schemas.openxmlformats.org/drawingml/2006/main">
          <a:off x="1571636" y="357190"/>
          <a:ext cx="357190" cy="22132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r>
            <a:rPr lang="en-US" sz="1400" dirty="0"/>
            <a:t>***</a:t>
          </a:r>
        </a:p>
      </cdr:txBody>
    </cdr:sp>
  </cdr:relSizeAnchor>
  <cdr:relSizeAnchor xmlns:cdr="http://schemas.openxmlformats.org/drawingml/2006/chartDrawing">
    <cdr:from>
      <cdr:x>0.3</cdr:x>
      <cdr:y>0.17327</cdr:y>
    </cdr:from>
    <cdr:to>
      <cdr:x>0.38333</cdr:x>
      <cdr:y>0.24996</cdr:y>
    </cdr:to>
    <cdr:sp macro="" textlink="">
      <cdr:nvSpPr>
        <cdr:cNvPr id="6" name="TextBox 1"/>
        <cdr:cNvSpPr txBox="1"/>
      </cdr:nvSpPr>
      <cdr:spPr>
        <a:xfrm xmlns:a="http://schemas.openxmlformats.org/drawingml/2006/main">
          <a:off x="1285884" y="500066"/>
          <a:ext cx="357190" cy="22132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none" rtlCol="0"/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pPr>
            <a:lnSpc>
              <a:spcPts val="1600"/>
            </a:lnSpc>
          </a:pPr>
          <a:r>
            <a:rPr lang="en-US" sz="1400" dirty="0"/>
            <a:t>***</a:t>
          </a: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t-E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t-E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48F530-EA0E-4B46-97DC-C0A61CAEDDA4}" type="datetimeFigureOut">
              <a:rPr lang="et-EE" smtClean="0"/>
              <a:pPr/>
              <a:t>15.11.2020</a:t>
            </a:fld>
            <a:endParaRPr lang="et-E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t-E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7098F-4428-43C2-A6C3-FA2D64E05CCF}" type="slidenum">
              <a:rPr lang="et-EE" smtClean="0"/>
              <a:pPr/>
              <a:t>‹#›</a:t>
            </a:fld>
            <a:endParaRPr lang="et-E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t-E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t-E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48F530-EA0E-4B46-97DC-C0A61CAEDDA4}" type="datetimeFigureOut">
              <a:rPr lang="et-EE" smtClean="0"/>
              <a:pPr/>
              <a:t>15.11.2020</a:t>
            </a:fld>
            <a:endParaRPr lang="et-E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t-E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7098F-4428-43C2-A6C3-FA2D64E05CCF}" type="slidenum">
              <a:rPr lang="et-EE" smtClean="0"/>
              <a:pPr/>
              <a:t>‹#›</a:t>
            </a:fld>
            <a:endParaRPr lang="et-E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t-E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t-E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48F530-EA0E-4B46-97DC-C0A61CAEDDA4}" type="datetimeFigureOut">
              <a:rPr lang="et-EE" smtClean="0"/>
              <a:pPr/>
              <a:t>15.11.2020</a:t>
            </a:fld>
            <a:endParaRPr lang="et-E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t-E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7098F-4428-43C2-A6C3-FA2D64E05CCF}" type="slidenum">
              <a:rPr lang="et-EE" smtClean="0"/>
              <a:pPr/>
              <a:t>‹#›</a:t>
            </a:fld>
            <a:endParaRPr lang="et-E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t-E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t-E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48F530-EA0E-4B46-97DC-C0A61CAEDDA4}" type="datetimeFigureOut">
              <a:rPr lang="et-EE" smtClean="0"/>
              <a:pPr/>
              <a:t>15.11.2020</a:t>
            </a:fld>
            <a:endParaRPr lang="et-E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t-E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7098F-4428-43C2-A6C3-FA2D64E05CCF}" type="slidenum">
              <a:rPr lang="et-EE" smtClean="0"/>
              <a:pPr/>
              <a:t>‹#›</a:t>
            </a:fld>
            <a:endParaRPr lang="et-E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t-E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48F530-EA0E-4B46-97DC-C0A61CAEDDA4}" type="datetimeFigureOut">
              <a:rPr lang="et-EE" smtClean="0"/>
              <a:pPr/>
              <a:t>15.11.2020</a:t>
            </a:fld>
            <a:endParaRPr lang="et-E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t-E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7098F-4428-43C2-A6C3-FA2D64E05CCF}" type="slidenum">
              <a:rPr lang="et-EE" smtClean="0"/>
              <a:pPr/>
              <a:t>‹#›</a:t>
            </a:fld>
            <a:endParaRPr lang="et-E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t-E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t-E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t-E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48F530-EA0E-4B46-97DC-C0A61CAEDDA4}" type="datetimeFigureOut">
              <a:rPr lang="et-EE" smtClean="0"/>
              <a:pPr/>
              <a:t>15.11.2020</a:t>
            </a:fld>
            <a:endParaRPr lang="et-E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t-E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7098F-4428-43C2-A6C3-FA2D64E05CCF}" type="slidenum">
              <a:rPr lang="et-EE" smtClean="0"/>
              <a:pPr/>
              <a:t>‹#›</a:t>
            </a:fld>
            <a:endParaRPr lang="et-E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t-E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t-E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t-E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48F530-EA0E-4B46-97DC-C0A61CAEDDA4}" type="datetimeFigureOut">
              <a:rPr lang="et-EE" smtClean="0"/>
              <a:pPr/>
              <a:t>15.11.2020</a:t>
            </a:fld>
            <a:endParaRPr lang="et-E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t-E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7098F-4428-43C2-A6C3-FA2D64E05CCF}" type="slidenum">
              <a:rPr lang="et-EE" smtClean="0"/>
              <a:pPr/>
              <a:t>‹#›</a:t>
            </a:fld>
            <a:endParaRPr lang="et-E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t-E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48F530-EA0E-4B46-97DC-C0A61CAEDDA4}" type="datetimeFigureOut">
              <a:rPr lang="et-EE" smtClean="0"/>
              <a:pPr/>
              <a:t>15.11.2020</a:t>
            </a:fld>
            <a:endParaRPr lang="et-E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t-E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7098F-4428-43C2-A6C3-FA2D64E05CCF}" type="slidenum">
              <a:rPr lang="et-EE" smtClean="0"/>
              <a:pPr/>
              <a:t>‹#›</a:t>
            </a:fld>
            <a:endParaRPr lang="et-E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48F530-EA0E-4B46-97DC-C0A61CAEDDA4}" type="datetimeFigureOut">
              <a:rPr lang="et-EE" smtClean="0"/>
              <a:pPr/>
              <a:t>15.11.2020</a:t>
            </a:fld>
            <a:endParaRPr lang="et-E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t-E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7098F-4428-43C2-A6C3-FA2D64E05CCF}" type="slidenum">
              <a:rPr lang="et-EE" smtClean="0"/>
              <a:pPr/>
              <a:t>‹#›</a:t>
            </a:fld>
            <a:endParaRPr lang="et-E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t-E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t-E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48F530-EA0E-4B46-97DC-C0A61CAEDDA4}" type="datetimeFigureOut">
              <a:rPr lang="et-EE" smtClean="0"/>
              <a:pPr/>
              <a:t>15.11.2020</a:t>
            </a:fld>
            <a:endParaRPr lang="et-E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t-E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7098F-4428-43C2-A6C3-FA2D64E05CCF}" type="slidenum">
              <a:rPr lang="et-EE" smtClean="0"/>
              <a:pPr/>
              <a:t>‹#›</a:t>
            </a:fld>
            <a:endParaRPr lang="et-E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t-E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t-E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48F530-EA0E-4B46-97DC-C0A61CAEDDA4}" type="datetimeFigureOut">
              <a:rPr lang="et-EE" smtClean="0"/>
              <a:pPr/>
              <a:t>15.11.2020</a:t>
            </a:fld>
            <a:endParaRPr lang="et-E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t-E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07098F-4428-43C2-A6C3-FA2D64E05CCF}" type="slidenum">
              <a:rPr lang="et-EE" smtClean="0"/>
              <a:pPr/>
              <a:t>‹#›</a:t>
            </a:fld>
            <a:endParaRPr lang="et-E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t-E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t-E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48F530-EA0E-4B46-97DC-C0A61CAEDDA4}" type="datetimeFigureOut">
              <a:rPr lang="et-EE" smtClean="0"/>
              <a:pPr/>
              <a:t>15.11.2020</a:t>
            </a:fld>
            <a:endParaRPr lang="et-E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t-E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07098F-4428-43C2-A6C3-FA2D64E05CCF}" type="slidenum">
              <a:rPr lang="et-EE" smtClean="0"/>
              <a:pPr/>
              <a:t>‹#›</a:t>
            </a:fld>
            <a:endParaRPr lang="et-E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t-E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>
            <p:extLst>
              <p:ext uri="{D42A27DB-BD31-4B8C-83A1-F6EECF244321}">
                <p14:modId xmlns:p14="http://schemas.microsoft.com/office/powerpoint/2010/main" val="896351329"/>
              </p:ext>
            </p:extLst>
          </p:nvPr>
        </p:nvGraphicFramePr>
        <p:xfrm>
          <a:off x="1835696" y="1628800"/>
          <a:ext cx="5760640" cy="30243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Rectangle 5">
            <a:extLst>
              <a:ext uri="{FF2B5EF4-FFF2-40B4-BE49-F238E27FC236}">
                <a16:creationId xmlns:a16="http://schemas.microsoft.com/office/drawing/2014/main" id="{E861C5EF-3D32-4E9F-A565-5FB92C541522}"/>
              </a:ext>
            </a:extLst>
          </p:cNvPr>
          <p:cNvSpPr/>
          <p:nvPr/>
        </p:nvSpPr>
        <p:spPr>
          <a:xfrm>
            <a:off x="323528" y="188640"/>
            <a:ext cx="242297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upplementary figure 2</a:t>
            </a:r>
            <a:endParaRPr lang="et-EE" dirty="0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7DC2BCCC-75CF-4E9F-9A56-CC3A281BB36D}"/>
              </a:ext>
            </a:extLst>
          </p:cNvPr>
          <p:cNvSpPr/>
          <p:nvPr/>
        </p:nvSpPr>
        <p:spPr>
          <a:xfrm>
            <a:off x="647564" y="5027262"/>
            <a:ext cx="8136904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.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he effect of NaBT on the survival of Caco-2 cells in trypan blue excluding test: exposure time was 48 hours. Bars are SEM (n = 3); ***</a:t>
            </a:r>
            <a:r>
              <a:rPr lang="en-US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&lt;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0.001 (Student’s t test).</a:t>
            </a:r>
            <a:endParaRPr lang="en-GB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8</TotalTime>
  <Words>56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aco-2 cells</dc:title>
  <dc:creator>Aleksandr</dc:creator>
  <cp:lastModifiedBy>Ljudmila Ounpuu</cp:lastModifiedBy>
  <cp:revision>10</cp:revision>
  <dcterms:created xsi:type="dcterms:W3CDTF">2019-09-12T06:14:59Z</dcterms:created>
  <dcterms:modified xsi:type="dcterms:W3CDTF">2020-11-15T19:41:31Z</dcterms:modified>
</cp:coreProperties>
</file>